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8"/>
  </p:notesMasterIdLst>
  <p:sldIdLst>
    <p:sldId id="1130" r:id="rId2"/>
    <p:sldId id="1131" r:id="rId3"/>
    <p:sldId id="1133" r:id="rId4"/>
    <p:sldId id="1134" r:id="rId5"/>
    <p:sldId id="1135" r:id="rId6"/>
    <p:sldId id="113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64693E5C-82CA-495E-B912-08DE5108B489}">
          <p14:sldIdLst>
            <p14:sldId id="1130"/>
            <p14:sldId id="1131"/>
            <p14:sldId id="1133"/>
            <p14:sldId id="1134"/>
            <p14:sldId id="1135"/>
            <p14:sldId id="113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364" userDrawn="1">
          <p15:clr>
            <a:srgbClr val="A4A3A4"/>
          </p15:clr>
        </p15:guide>
        <p15:guide id="2" pos="3795" userDrawn="1">
          <p15:clr>
            <a:srgbClr val="A4A3A4"/>
          </p15:clr>
        </p15:guide>
        <p15:guide id="3" orient="horz">
          <p15:clr>
            <a:srgbClr val="A4A3A4"/>
          </p15:clr>
        </p15:guide>
        <p15:guide id="4" pos="370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n Xudong" initials="SX" lastIdx="1" clrIdx="0">
    <p:extLst>
      <p:ext uri="{19B8F6BF-5375-455C-9EA6-DF929625EA0E}">
        <p15:presenceInfo xmlns:p15="http://schemas.microsoft.com/office/powerpoint/2012/main" userId="b3f7c8f1d3c87e8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33CCCC"/>
    <a:srgbClr val="008080"/>
    <a:srgbClr val="009999"/>
    <a:srgbClr val="00CC66"/>
    <a:srgbClr val="00CC99"/>
    <a:srgbClr val="0000CC"/>
    <a:srgbClr val="FFCCCC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397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235" y="72"/>
      </p:cViewPr>
      <p:guideLst>
        <p:guide orient="horz" pos="2364"/>
        <p:guide pos="3795"/>
        <p:guide orient="horz"/>
        <p:guide pos="370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23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6DC3A5-4250-4ADA-B7E9-00FBE7167774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EF9289-D74A-46F8-A829-2761470A4DF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433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E1DDC95B-521F-4227-9741-38ACC49773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2E52E07A-9BE0-4D3C-B444-CF8B0C2161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641ED17F-4F9A-442B-90A4-1E74E123A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813CCC1D-F087-44A3-894D-69B7FA833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806F9F3-BE72-4EF7-B3EC-933116FD8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1166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A0B95449-FDB1-4226-9DB5-6EB612789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C24E51EE-5D3B-4F80-A242-72F1ECE663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ADCBCC1-F009-41A3-BB6E-21E5B967D0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2B6F377-4DC7-4EFC-962C-FC44B9DE0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F31809E-F4D0-4BED-83DC-22BEDED8B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6408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9E755E7A-9C75-47D8-8CA8-589CB0445B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C4650D2C-0544-42C1-98EF-4C05FFC4A1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45FE0ABC-719E-45EC-8F05-4B401ACCC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EF46A626-F110-4A13-82E8-3D73FAC8B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2659D209-70F4-4DB5-A11E-E0673019B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596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F527313-1642-4419-B5DF-00BD1EEC1B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CCD3B83C-A7D6-4071-AFEB-58EA16FBDD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FA622F5-1FA4-4CB1-B975-D1061C35A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9601BBB-BC14-4840-9271-3CB083054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D379E17-5FF8-4D79-9D1D-72268CB6E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3361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0A2D080-1660-4B2B-8B66-505830867A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5955748A-1587-476F-B8E1-9CC6A73E96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42CF88A-EA0B-463A-B01B-B66BA2335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11031AE2-162D-41BB-ABEE-52491FF0C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6F5903E-9424-4DA7-A562-D11486217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4779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A4CDE7BD-AEF1-40FB-8709-B23CF74C5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F0C35895-0E91-47ED-A305-534F9362AB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26177C37-B56B-4C2C-A715-2FE828A9E6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1868CE1B-EC96-454A-A113-1A7B315A8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FCDD5CA-A417-49D2-B22B-B40F942D6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88EA7FBE-1195-441E-80CD-95EEE60CC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6533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870619C-40BD-4682-8F5B-F28AF63CEC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F9B39836-7CE6-4AEA-961B-9F36F82CD7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F6AF1C88-43DF-4A21-8C07-3B37470C7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0BC0C98F-593A-4F6A-A98D-810394379C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FB3FDC0B-FADB-4688-9441-972230CD31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11F79285-245C-4071-A8AE-A8793FA96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7F9475A5-E276-4346-B1A5-96A4BCE96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B71B5E56-D2C6-46F5-962E-337B5C1F16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183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A8937F6-A107-4BE3-8077-AB3EF42773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05E2334C-C17B-4CAE-A715-2A577E433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9D9CEDA5-730D-438A-80CD-552767877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68382C25-9A7B-46E7-B532-8D6E50B36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615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004EE785-6C7B-44B8-882B-9CB851EE4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284C1C90-52F8-4668-B384-DCD67BB69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5F9CC807-D69A-4AD1-BD61-B9790DC95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126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B2FA464-7E77-4A71-8394-A7B3C34151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2AE3AB07-28D9-486D-AE23-8FFFB87192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47BCA10B-3724-4E4D-979E-C9074BC633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BDE885C3-1EDB-48D6-A2F5-C72B62FB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6CFD8374-A784-4872-927B-D55C9D79C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C08B1A2F-C40B-4E97-95FE-1A27DE713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874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B358FCCD-69AA-4F70-A1BE-04E3D3605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985F7986-7996-4854-BFD0-E3DA560653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A87F3C00-1AB7-4C27-B775-5DE1B5CD0E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161762B5-0B33-480C-81B1-ABCAA3510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7C0FC29F-E9FB-42DE-A4D4-3C1256462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42D78C3A-9ABF-4748-B716-26A72DD52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510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93276E37-B947-4272-AFB3-43045C096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92562D3-D989-42E1-85BD-13B463ACD3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36C07E1-44AF-4BA7-BE7C-220AB4C05F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5B79D5-66A1-4FE2-8BFE-619016FF11F3}" type="datetimeFigureOut">
              <a:rPr lang="zh-CN" altLang="en-US" smtClean="0"/>
              <a:pPr/>
              <a:t>2022/7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247BD919-39EC-4A52-AE6D-4F5DF6B258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A2026DE0-8ABF-49BA-B95D-8BA8E17072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206AD-336E-4CE2-98D6-052D8CC7060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97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535621" y="1064591"/>
            <a:ext cx="4064169" cy="2815445"/>
            <a:chOff x="2560535" y="1105798"/>
            <a:chExt cx="4064169" cy="2815445"/>
          </a:xfrm>
        </p:grpSpPr>
        <p:graphicFrame>
          <p:nvGraphicFramePr>
            <p:cNvPr id="5" name="对象 4"/>
            <p:cNvGraphicFramePr>
              <a:graphicFrameLocks noChangeAspect="1"/>
            </p:cNvGraphicFramePr>
            <p:nvPr/>
          </p:nvGraphicFramePr>
          <p:xfrm>
            <a:off x="2842578" y="1105798"/>
            <a:ext cx="3557894" cy="2695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1" name="SPW 10.0 Graph" r:id="rId3" imgW="5229360" imgH="3961800" progId="SigmaPlotGraphicObject.9">
                    <p:embed/>
                  </p:oleObj>
                </mc:Choice>
                <mc:Fallback>
                  <p:oleObj name="SPW 10.0 Graph" r:id="rId3" imgW="5229360" imgH="3961800" progId="SigmaPlotGraphicObject.9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842578" y="1105798"/>
                          <a:ext cx="3557894" cy="2695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文本框 9"/>
            <p:cNvSpPr txBox="1"/>
            <p:nvPr/>
          </p:nvSpPr>
          <p:spPr>
            <a:xfrm>
              <a:off x="3234896" y="3687461"/>
              <a:ext cx="3389808" cy="2337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19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     </a:t>
              </a:r>
              <a:r>
                <a:rPr kumimoji="0" lang="en-US" altLang="zh-CN" sz="919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BrrWUS</a:t>
              </a:r>
              <a:r>
                <a:rPr kumimoji="0" lang="en-US" altLang="zh-CN" sz="919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                    </a:t>
              </a:r>
              <a:r>
                <a:rPr kumimoji="0" lang="en-US" altLang="zh-CN" sz="919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BrrWUSa</a:t>
              </a:r>
              <a:r>
                <a:rPr kumimoji="0" lang="en-US" altLang="zh-CN" sz="919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                   </a:t>
              </a:r>
              <a:r>
                <a:rPr kumimoji="0" lang="en-US" altLang="zh-CN" sz="919" b="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/>
                </a:rPr>
                <a:t>BrrWUSb</a:t>
              </a:r>
              <a:endParaRPr kumimoji="0" lang="zh-CN" altLang="en-US" sz="919" b="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/>
              </a:endParaRPr>
            </a:p>
          </p:txBody>
        </p:sp>
        <p:sp>
          <p:nvSpPr>
            <p:cNvPr id="7" name="文本框 10"/>
            <p:cNvSpPr txBox="1"/>
            <p:nvPr/>
          </p:nvSpPr>
          <p:spPr>
            <a:xfrm rot="10800000">
              <a:off x="2560535" y="1482193"/>
              <a:ext cx="326115" cy="19150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19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dobe 黑体 Std R" panose="020B0400000000000000" pitchFamily="34" charset="-122"/>
                  <a:ea typeface="Adobe 黑体 Std R" panose="020B0400000000000000" pitchFamily="34" charset="-122"/>
                </a:rPr>
                <a:t>Relative expression level</a:t>
              </a:r>
            </a:p>
          </p:txBody>
        </p:sp>
      </p:grpSp>
      <p:sp>
        <p:nvSpPr>
          <p:cNvPr id="9" name="矩形 8"/>
          <p:cNvSpPr/>
          <p:nvPr/>
        </p:nvSpPr>
        <p:spPr>
          <a:xfrm>
            <a:off x="3383360" y="4369063"/>
            <a:ext cx="6096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lative expression levels of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rWUS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rWUSa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rWUSb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turnip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M</a:t>
            </a:r>
            <a:r>
              <a:rPr lang="en-US" altLang="zh-CN" sz="1200" dirty="0">
                <a:solidFill>
                  <a:srgbClr val="FF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SAM, the shoot apex of junction of 7-day-old turnip plants were isolated through excising hypocotyl and leaves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2-ΔΔCt method was used to calculate the relative expression levels. The tubulin gene was selected as an internal reference to normalize the expression of the target gene.</a:t>
            </a:r>
            <a:r>
              <a:rPr lang="en-US" altLang="zh-CN" sz="1200" kern="100" dirty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rror bars represent Standard Deviation of triplicate experiments and letters above the bars denote significant difference at P&lt;0.05(Turkey’s test).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5502656" y="288022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358351" y="294706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431360" y="144098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11177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CAFEE8BB-3CC3-48D5-93D9-5A58AFC96DD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98" r="17622" b="3159"/>
          <a:stretch/>
        </p:blipFill>
        <p:spPr>
          <a:xfrm flipH="1">
            <a:off x="3363969" y="1632360"/>
            <a:ext cx="1440000" cy="143776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="" xmlns:a16="http://schemas.microsoft.com/office/drawing/2014/main" id="{CD35BF45-B8A6-4E7A-9ACC-BCC5AE639AC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03" t="19588" r="27059" b="58162"/>
          <a:stretch/>
        </p:blipFill>
        <p:spPr>
          <a:xfrm flipH="1">
            <a:off x="4841099" y="1632360"/>
            <a:ext cx="1440000" cy="1437760"/>
          </a:xfrm>
          <a:prstGeom prst="rect">
            <a:avLst/>
          </a:prstGeom>
        </p:spPr>
      </p:pic>
      <p:cxnSp>
        <p:nvCxnSpPr>
          <p:cNvPr id="4" name="直接箭头连接符 3">
            <a:extLst>
              <a:ext uri="{FF2B5EF4-FFF2-40B4-BE49-F238E27FC236}">
                <a16:creationId xmlns="" xmlns:a16="http://schemas.microsoft.com/office/drawing/2014/main" id="{5BFD4066-B8B1-4EDE-A51A-B34A31FE5ABF}"/>
              </a:ext>
            </a:extLst>
          </p:cNvPr>
          <p:cNvCxnSpPr/>
          <p:nvPr/>
        </p:nvCxnSpPr>
        <p:spPr>
          <a:xfrm flipH="1">
            <a:off x="3801757" y="2027335"/>
            <a:ext cx="174458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="" xmlns:a16="http://schemas.microsoft.com/office/drawing/2014/main" id="{C15DFC6F-7095-4480-A96D-E1D284B2FDA7}"/>
              </a:ext>
            </a:extLst>
          </p:cNvPr>
          <p:cNvSpPr txBox="1"/>
          <p:nvPr/>
        </p:nvSpPr>
        <p:spPr>
          <a:xfrm>
            <a:off x="3303927" y="1605229"/>
            <a:ext cx="3202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958C14C8-B438-45B7-9EF9-3D348567FDC5}"/>
              </a:ext>
            </a:extLst>
          </p:cNvPr>
          <p:cNvSpPr txBox="1"/>
          <p:nvPr/>
        </p:nvSpPr>
        <p:spPr>
          <a:xfrm>
            <a:off x="4791673" y="1614194"/>
            <a:ext cx="302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3262228" y="3429000"/>
            <a:ext cx="6096000" cy="117077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Phenotype of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5S:BrrWUSa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plants. 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Ectopic leaf bud formed on the leaf surface of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5S:BrrWUSa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plants. (b) zoomed image of arrowhead site in (a). (c), the photograph shows inflorescence of </a:t>
            </a:r>
            <a:r>
              <a:rPr lang="en-US" altLang="zh-CN" sz="12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5S:BrrWUSa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ransgenic plants. (d) zoomed image of box site in (c).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89D676D5-4710-9782-0C84-2C87A39545D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5117"/>
          <a:stretch/>
        </p:blipFill>
        <p:spPr>
          <a:xfrm flipH="1">
            <a:off x="6318229" y="1632360"/>
            <a:ext cx="1440000" cy="143776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31CAAED5-E757-E3CA-572A-5CB68085C64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26" t="53071" r="33943" b="24313"/>
          <a:stretch/>
        </p:blipFill>
        <p:spPr>
          <a:xfrm rot="16200000">
            <a:off x="7795359" y="1632360"/>
            <a:ext cx="1440000" cy="1436400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="" xmlns:a16="http://schemas.microsoft.com/office/drawing/2014/main" id="{7A1E7E14-2FFC-DB01-4C5B-80D6D1F40C05}"/>
              </a:ext>
            </a:extLst>
          </p:cNvPr>
          <p:cNvSpPr/>
          <p:nvPr/>
        </p:nvSpPr>
        <p:spPr>
          <a:xfrm>
            <a:off x="6763398" y="2027335"/>
            <a:ext cx="210552" cy="30680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="" xmlns:a16="http://schemas.microsoft.com/office/drawing/2014/main" id="{92C2CA32-D05E-54C2-2A4C-037803A5618A}"/>
              </a:ext>
            </a:extLst>
          </p:cNvPr>
          <p:cNvSpPr txBox="1"/>
          <p:nvPr/>
        </p:nvSpPr>
        <p:spPr>
          <a:xfrm>
            <a:off x="6261884" y="1597656"/>
            <a:ext cx="302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="" xmlns:a16="http://schemas.microsoft.com/office/drawing/2014/main" id="{C899B949-C088-AD38-D5DA-9156067DE3F3}"/>
              </a:ext>
            </a:extLst>
          </p:cNvPr>
          <p:cNvSpPr txBox="1"/>
          <p:nvPr/>
        </p:nvSpPr>
        <p:spPr>
          <a:xfrm>
            <a:off x="7767611" y="1605228"/>
            <a:ext cx="302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73064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38131"/>
    </mc:Choice>
    <mc:Fallback xmlns="">
      <p:transition spd="slow" advTm="38131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26651" y="557829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3139928" y="289796"/>
            <a:ext cx="425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R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3478508" y="707304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右箭头 6"/>
          <p:cNvSpPr/>
          <p:nvPr/>
        </p:nvSpPr>
        <p:spPr>
          <a:xfrm>
            <a:off x="3780512" y="517926"/>
            <a:ext cx="929076" cy="347165"/>
          </a:xfrm>
          <a:prstGeom prst="rightArrow">
            <a:avLst/>
          </a:prstGeom>
          <a:solidFill>
            <a:schemeClr val="accent4">
              <a:lumMod val="60000"/>
              <a:lumOff val="40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3949408" y="359837"/>
            <a:ext cx="527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35S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4709588" y="582363"/>
            <a:ext cx="1003851" cy="223094"/>
          </a:xfrm>
          <a:prstGeom prst="rect">
            <a:avLst/>
          </a:prstGeom>
          <a:solidFill>
            <a:srgbClr val="7DF32D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4901172" y="328931"/>
            <a:ext cx="620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EGFP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748226" y="312364"/>
            <a:ext cx="10070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 err="1">
                <a:latin typeface="Comic Sans MS" panose="030F0702030302020204" pitchFamily="66" charset="0"/>
                <a:cs typeface="Times New Roman" panose="02020603050405020304" pitchFamily="18" charset="0"/>
              </a:rPr>
              <a:t>BrrWUSa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5787183" y="572424"/>
            <a:ext cx="1003851" cy="223094"/>
          </a:xfrm>
          <a:prstGeom prst="rect">
            <a:avLst/>
          </a:prstGeom>
          <a:solidFill>
            <a:srgbClr val="FF0000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直接连接符 12"/>
          <p:cNvCxnSpPr/>
          <p:nvPr/>
        </p:nvCxnSpPr>
        <p:spPr>
          <a:xfrm>
            <a:off x="5713439" y="707304"/>
            <a:ext cx="695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7508057" y="714305"/>
            <a:ext cx="12417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矩形 14"/>
          <p:cNvSpPr/>
          <p:nvPr/>
        </p:nvSpPr>
        <p:spPr>
          <a:xfrm>
            <a:off x="7646906" y="559548"/>
            <a:ext cx="617260" cy="242972"/>
          </a:xfrm>
          <a:prstGeom prst="rect">
            <a:avLst/>
          </a:prstGeom>
          <a:solidFill>
            <a:schemeClr val="bg2">
              <a:lumMod val="50000"/>
            </a:schemeClr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7631026" y="303890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NOS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8264166" y="706826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矩形 17"/>
          <p:cNvSpPr/>
          <p:nvPr/>
        </p:nvSpPr>
        <p:spPr>
          <a:xfrm>
            <a:off x="8579821" y="559994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8506723" y="301321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L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3205329" y="1144628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3" name="直接连接符 22"/>
          <p:cNvCxnSpPr/>
          <p:nvPr/>
        </p:nvCxnSpPr>
        <p:spPr>
          <a:xfrm>
            <a:off x="3457186" y="1276055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右箭头 23"/>
          <p:cNvSpPr/>
          <p:nvPr/>
        </p:nvSpPr>
        <p:spPr>
          <a:xfrm>
            <a:off x="3759190" y="1104725"/>
            <a:ext cx="929076" cy="347165"/>
          </a:xfrm>
          <a:prstGeom prst="rightArrow">
            <a:avLst/>
          </a:prstGeom>
          <a:solidFill>
            <a:schemeClr val="accent4">
              <a:lumMod val="60000"/>
              <a:lumOff val="40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4688267" y="1169162"/>
            <a:ext cx="696508" cy="213155"/>
          </a:xfrm>
          <a:prstGeom prst="rect">
            <a:avLst/>
          </a:prstGeom>
          <a:solidFill>
            <a:schemeClr val="accent2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3137084" y="894948"/>
            <a:ext cx="425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R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979895" y="931274"/>
            <a:ext cx="527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35S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740765" y="89559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XVE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29" name="直接箭头连接符 28"/>
          <p:cNvCxnSpPr>
            <a:stCxn id="25" idx="3"/>
          </p:cNvCxnSpPr>
          <p:nvPr/>
        </p:nvCxnSpPr>
        <p:spPr>
          <a:xfrm flipV="1">
            <a:off x="5384775" y="1275739"/>
            <a:ext cx="1508019" cy="1"/>
          </a:xfrm>
          <a:prstGeom prst="straightConnector1">
            <a:avLst/>
          </a:prstGeom>
          <a:ln w="47625">
            <a:solidFill>
              <a:schemeClr val="accent1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5356487" y="958023"/>
            <a:ext cx="1454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</a:rPr>
              <a:t>P</a:t>
            </a:r>
            <a:r>
              <a:rPr lang="en-US" altLang="zh-CN" sz="1400" i="1" baseline="-25000" dirty="0">
                <a:latin typeface="Comic Sans MS" panose="030F0702030302020204" pitchFamily="66" charset="0"/>
              </a:rPr>
              <a:t>NOS</a:t>
            </a:r>
            <a:r>
              <a:rPr lang="en-US" altLang="zh-CN" sz="1400" i="1" dirty="0">
                <a:latin typeface="Comic Sans MS" panose="030F0702030302020204" pitchFamily="66" charset="0"/>
              </a:rPr>
              <a:t>-HPT-T</a:t>
            </a:r>
            <a:r>
              <a:rPr lang="en-US" altLang="zh-CN" sz="1400" i="1" baseline="-25000" dirty="0">
                <a:latin typeface="Comic Sans MS" panose="030F0702030302020204" pitchFamily="66" charset="0"/>
              </a:rPr>
              <a:t>NOS</a:t>
            </a:r>
            <a:endParaRPr lang="zh-CN" altLang="zh-CN" sz="1400" i="1" dirty="0">
              <a:latin typeface="Comic Sans MS" panose="030F0702030302020204" pitchFamily="66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6887327" y="1271381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右箭头 31"/>
          <p:cNvSpPr/>
          <p:nvPr/>
        </p:nvSpPr>
        <p:spPr>
          <a:xfrm>
            <a:off x="7189592" y="1077757"/>
            <a:ext cx="1094156" cy="406478"/>
          </a:xfrm>
          <a:prstGeom prst="rightArrow">
            <a:avLst/>
          </a:prstGeom>
          <a:solidFill>
            <a:schemeClr val="accent1">
              <a:lumMod val="75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7174546" y="904639"/>
            <a:ext cx="91082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i="1" kern="100" dirty="0">
                <a:latin typeface="Comic Sans MS" panose="030F0702030302020204" pitchFamily="66" charset="0"/>
                <a:cs typeface="Times New Roman" panose="02020603050405020304" pitchFamily="18" charset="0"/>
              </a:rPr>
              <a:t>O</a:t>
            </a:r>
            <a:r>
              <a:rPr lang="en-US" altLang="zh-CN" sz="1400" i="1" kern="100" baseline="-25000" dirty="0">
                <a:latin typeface="Comic Sans MS" panose="030F0702030302020204" pitchFamily="66" charset="0"/>
                <a:cs typeface="Times New Roman" panose="02020603050405020304" pitchFamily="18" charset="0"/>
              </a:rPr>
              <a:t>LexA</a:t>
            </a:r>
            <a:r>
              <a:rPr lang="en-US" altLang="zh-CN" sz="1400" i="1" kern="100" dirty="0">
                <a:latin typeface="Comic Sans MS" panose="030F0702030302020204" pitchFamily="66" charset="0"/>
                <a:cs typeface="Times New Roman" panose="02020603050405020304" pitchFamily="18" charset="0"/>
              </a:rPr>
              <a:t>-46</a:t>
            </a:r>
            <a:endParaRPr lang="zh-CN" altLang="zh-CN" sz="1400" i="1" kern="1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8283748" y="1171406"/>
            <a:ext cx="1003851" cy="223094"/>
          </a:xfrm>
          <a:prstGeom prst="rect">
            <a:avLst/>
          </a:prstGeom>
          <a:solidFill>
            <a:srgbClr val="FF0000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/>
          <p:cNvSpPr txBox="1"/>
          <p:nvPr/>
        </p:nvSpPr>
        <p:spPr>
          <a:xfrm>
            <a:off x="8258329" y="897701"/>
            <a:ext cx="10070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 err="1">
                <a:latin typeface="Comic Sans MS" panose="030F0702030302020204" pitchFamily="66" charset="0"/>
                <a:cs typeface="Times New Roman" panose="02020603050405020304" pitchFamily="18" charset="0"/>
              </a:rPr>
              <a:t>BrrWUSa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9814430" y="1304174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矩形 36"/>
          <p:cNvSpPr/>
          <p:nvPr/>
        </p:nvSpPr>
        <p:spPr>
          <a:xfrm>
            <a:off x="10114319" y="1159624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文本框 37"/>
          <p:cNvSpPr txBox="1"/>
          <p:nvPr/>
        </p:nvSpPr>
        <p:spPr>
          <a:xfrm>
            <a:off x="9307492" y="843751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3Flag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3188424" y="1814260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1" name="直接连接符 40"/>
          <p:cNvCxnSpPr/>
          <p:nvPr/>
        </p:nvCxnSpPr>
        <p:spPr>
          <a:xfrm>
            <a:off x="3440281" y="1945687"/>
            <a:ext cx="30200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右箭头 41"/>
          <p:cNvSpPr/>
          <p:nvPr/>
        </p:nvSpPr>
        <p:spPr>
          <a:xfrm>
            <a:off x="4939267" y="1753956"/>
            <a:ext cx="797030" cy="347165"/>
          </a:xfrm>
          <a:prstGeom prst="rightArrow">
            <a:avLst/>
          </a:prstGeom>
          <a:solidFill>
            <a:schemeClr val="accent4">
              <a:lumMod val="60000"/>
              <a:lumOff val="40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/>
          <p:cNvSpPr txBox="1"/>
          <p:nvPr/>
        </p:nvSpPr>
        <p:spPr>
          <a:xfrm>
            <a:off x="3120179" y="1564580"/>
            <a:ext cx="410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R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46" name="右箭头 45"/>
          <p:cNvSpPr/>
          <p:nvPr/>
        </p:nvSpPr>
        <p:spPr>
          <a:xfrm>
            <a:off x="7423531" y="1679299"/>
            <a:ext cx="910061" cy="481254"/>
          </a:xfrm>
          <a:prstGeom prst="rightArrow">
            <a:avLst/>
          </a:prstGeom>
          <a:solidFill>
            <a:schemeClr val="accent2">
              <a:lumMod val="60000"/>
              <a:lumOff val="40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5747685" y="1801839"/>
            <a:ext cx="1003851" cy="223094"/>
          </a:xfrm>
          <a:prstGeom prst="rect">
            <a:avLst/>
          </a:prstGeom>
          <a:solidFill>
            <a:srgbClr val="00B0F0"/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文本框 47"/>
          <p:cNvSpPr txBox="1"/>
          <p:nvPr/>
        </p:nvSpPr>
        <p:spPr>
          <a:xfrm>
            <a:off x="5935770" y="1507457"/>
            <a:ext cx="580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Cas9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7180151" y="1924760"/>
            <a:ext cx="23462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矩形 49"/>
          <p:cNvSpPr/>
          <p:nvPr/>
        </p:nvSpPr>
        <p:spPr>
          <a:xfrm>
            <a:off x="9559783" y="1796687"/>
            <a:ext cx="251670" cy="2376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/>
          <p:cNvSpPr txBox="1"/>
          <p:nvPr/>
        </p:nvSpPr>
        <p:spPr>
          <a:xfrm>
            <a:off x="9483055" y="1543377"/>
            <a:ext cx="410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L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7357625" y="1562914"/>
            <a:ext cx="8050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U6-26t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3743879" y="1814260"/>
            <a:ext cx="425442" cy="237688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5" name="直接连接符 64"/>
          <p:cNvCxnSpPr/>
          <p:nvPr/>
        </p:nvCxnSpPr>
        <p:spPr>
          <a:xfrm>
            <a:off x="9315641" y="1933209"/>
            <a:ext cx="23462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6797859" y="707303"/>
            <a:ext cx="6957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矩形 68"/>
          <p:cNvSpPr/>
          <p:nvPr/>
        </p:nvSpPr>
        <p:spPr>
          <a:xfrm>
            <a:off x="6882110" y="552546"/>
            <a:ext cx="617260" cy="242972"/>
          </a:xfrm>
          <a:prstGeom prst="rect">
            <a:avLst/>
          </a:prstGeom>
          <a:solidFill>
            <a:srgbClr val="FFC000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文本框 69"/>
          <p:cNvSpPr txBox="1"/>
          <p:nvPr/>
        </p:nvSpPr>
        <p:spPr>
          <a:xfrm>
            <a:off x="6891661" y="302413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 err="1">
                <a:latin typeface="Comic Sans MS" panose="030F0702030302020204" pitchFamily="66" charset="0"/>
                <a:cs typeface="Times New Roman" panose="02020603050405020304" pitchFamily="18" charset="0"/>
              </a:rPr>
              <a:t>KanR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2900043" y="2335674"/>
            <a:ext cx="6365293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 Figure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hematic structure of three vectors.</a:t>
            </a:r>
          </a:p>
          <a:p>
            <a:pPr marL="228600">
              <a:lnSpc>
                <a:spcPct val="150000"/>
              </a:lnSpc>
              <a:buAutoNum type="alphaLcParenBoth"/>
            </a:pP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chematic diagram of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35S:BrrWUSa-GFP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35S promoter were used to drive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rWUSa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. EGFP was inserted into the vector for fluorescence observation. (b) Schematic diagram of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ER8-BrrWUSa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vector. XVE, an estradiol-inducible element was inserted into vector. (c) Schematic diagram of Cas9/</a:t>
            </a:r>
            <a:r>
              <a:rPr lang="en-US" altLang="zh-CN" sz="12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gRNA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inary vector.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rabidopsis thaliana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s AtU6-26t were used to drive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CP4b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. 2x35S promoter were used to drive 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s9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2623675" y="435475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2623675" y="10437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/>
          <p:cNvSpPr txBox="1"/>
          <p:nvPr/>
        </p:nvSpPr>
        <p:spPr>
          <a:xfrm>
            <a:off x="2649133" y="1700820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3656707" y="1530534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 err="1">
                <a:latin typeface="Comic Sans MS" panose="030F0702030302020204" pitchFamily="66" charset="0"/>
                <a:cs typeface="Times New Roman" panose="02020603050405020304" pitchFamily="18" charset="0"/>
              </a:rPr>
              <a:t>KanR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76" name="右箭头 75"/>
          <p:cNvSpPr/>
          <p:nvPr/>
        </p:nvSpPr>
        <p:spPr>
          <a:xfrm rot="10800000">
            <a:off x="4173322" y="1759972"/>
            <a:ext cx="696507" cy="347165"/>
          </a:xfrm>
          <a:prstGeom prst="rightArrow">
            <a:avLst/>
          </a:prstGeom>
          <a:solidFill>
            <a:schemeClr val="accent4">
              <a:lumMod val="60000"/>
              <a:lumOff val="40000"/>
              <a:alpha val="84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4356354" y="1634243"/>
            <a:ext cx="4768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35S</a:t>
            </a:r>
            <a:endParaRPr lang="zh-CN" altLang="en-US" sz="12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/>
          <p:cNvSpPr txBox="1"/>
          <p:nvPr/>
        </p:nvSpPr>
        <p:spPr>
          <a:xfrm>
            <a:off x="4878043" y="1629861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2X35S</a:t>
            </a:r>
            <a:endParaRPr lang="zh-CN" altLang="en-US" sz="12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79" name="矩形 78"/>
          <p:cNvSpPr/>
          <p:nvPr/>
        </p:nvSpPr>
        <p:spPr>
          <a:xfrm>
            <a:off x="6773604" y="1804485"/>
            <a:ext cx="400942" cy="220448"/>
          </a:xfrm>
          <a:prstGeom prst="rect">
            <a:avLst/>
          </a:prstGeom>
          <a:solidFill>
            <a:schemeClr val="bg2">
              <a:lumMod val="50000"/>
            </a:schemeClr>
          </a:solidFill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1" name="文本框 80"/>
          <p:cNvSpPr txBox="1"/>
          <p:nvPr/>
        </p:nvSpPr>
        <p:spPr>
          <a:xfrm>
            <a:off x="6669487" y="1525411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NOS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82" name="矩形 81"/>
          <p:cNvSpPr/>
          <p:nvPr/>
        </p:nvSpPr>
        <p:spPr>
          <a:xfrm>
            <a:off x="8343106" y="1800163"/>
            <a:ext cx="970317" cy="223094"/>
          </a:xfrm>
          <a:prstGeom prst="rect">
            <a:avLst/>
          </a:prstGeom>
          <a:solidFill>
            <a:srgbClr val="FF0000"/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sz="1200" i="1" dirty="0">
              <a:solidFill>
                <a:schemeClr val="tx1"/>
              </a:solidFill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84" name="直接连接符 83"/>
          <p:cNvCxnSpPr/>
          <p:nvPr/>
        </p:nvCxnSpPr>
        <p:spPr>
          <a:xfrm>
            <a:off x="9300673" y="1288237"/>
            <a:ext cx="12417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矩形 84"/>
          <p:cNvSpPr/>
          <p:nvPr/>
        </p:nvSpPr>
        <p:spPr>
          <a:xfrm>
            <a:off x="9431639" y="1151528"/>
            <a:ext cx="390022" cy="230789"/>
          </a:xfrm>
          <a:prstGeom prst="rect">
            <a:avLst/>
          </a:prstGeom>
          <a:solidFill>
            <a:schemeClr val="accent1">
              <a:lumMod val="75000"/>
            </a:schemeClr>
          </a:solidFill>
          <a:ln w="22225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6" name="文本框 85"/>
          <p:cNvSpPr txBox="1"/>
          <p:nvPr/>
        </p:nvSpPr>
        <p:spPr>
          <a:xfrm>
            <a:off x="10054822" y="884986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Comic Sans MS" panose="030F0702030302020204" pitchFamily="66" charset="0"/>
                <a:cs typeface="Times New Roman" panose="02020603050405020304" pitchFamily="18" charset="0"/>
              </a:rPr>
              <a:t>LB</a:t>
            </a:r>
            <a:endParaRPr lang="zh-CN" altLang="en-US" sz="1400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="" xmlns:a16="http://schemas.microsoft.com/office/drawing/2014/main" id="{7DFA4A86-F15E-4363-D878-A53A4CE70AD9}"/>
              </a:ext>
            </a:extLst>
          </p:cNvPr>
          <p:cNvSpPr txBox="1"/>
          <p:nvPr/>
        </p:nvSpPr>
        <p:spPr>
          <a:xfrm>
            <a:off x="8210148" y="1514307"/>
            <a:ext cx="1191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latin typeface="Comic Sans MS" panose="030F0702030302020204" pitchFamily="66" charset="0"/>
                <a:cs typeface="Times New Roman" panose="02020603050405020304" pitchFamily="18" charset="0"/>
              </a:rPr>
              <a:t>sgBrrTCP4b</a:t>
            </a:r>
            <a:endParaRPr lang="zh-CN" altLang="en-US" sz="1400" i="1" dirty="0">
              <a:latin typeface="Comic Sans MS" panose="030F0702030302020204" pitchFamily="66" charset="0"/>
              <a:cs typeface="Times New Roman" panose="02020603050405020304" pitchFamily="18" charset="0"/>
            </a:endParaRPr>
          </a:p>
        </p:txBody>
      </p:sp>
      <p:cxnSp>
        <p:nvCxnSpPr>
          <p:cNvPr id="75" name="直接连接符 74">
            <a:extLst>
              <a:ext uri="{FF2B5EF4-FFF2-40B4-BE49-F238E27FC236}">
                <a16:creationId xmlns="" xmlns:a16="http://schemas.microsoft.com/office/drawing/2014/main" id="{A60BE8A0-F154-16D4-472C-9F53CBA3B5AC}"/>
              </a:ext>
            </a:extLst>
          </p:cNvPr>
          <p:cNvCxnSpPr/>
          <p:nvPr/>
        </p:nvCxnSpPr>
        <p:spPr>
          <a:xfrm>
            <a:off x="4863375" y="1945687"/>
            <a:ext cx="7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922984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1958" y="61368"/>
            <a:ext cx="7709539" cy="5760000"/>
          </a:xfrm>
          <a:prstGeom prst="rect">
            <a:avLst/>
          </a:prstGeom>
        </p:spPr>
      </p:pic>
      <p:cxnSp>
        <p:nvCxnSpPr>
          <p:cNvPr id="13" name="直接连接符 12">
            <a:extLst>
              <a:ext uri="{FF2B5EF4-FFF2-40B4-BE49-F238E27FC236}">
                <a16:creationId xmlns="" xmlns:a16="http://schemas.microsoft.com/office/drawing/2014/main" id="{498CEC85-3090-4D0A-962F-52AA11EBD161}"/>
              </a:ext>
            </a:extLst>
          </p:cNvPr>
          <p:cNvCxnSpPr/>
          <p:nvPr/>
        </p:nvCxnSpPr>
        <p:spPr>
          <a:xfrm>
            <a:off x="3420623" y="3186107"/>
            <a:ext cx="146177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5">
            <a:extLst>
              <a:ext uri="{FF2B5EF4-FFF2-40B4-BE49-F238E27FC236}">
                <a16:creationId xmlns="" xmlns:a16="http://schemas.microsoft.com/office/drawing/2014/main" id="{02861760-5EA7-47CB-AAC9-328E8995A19B}"/>
              </a:ext>
            </a:extLst>
          </p:cNvPr>
          <p:cNvSpPr txBox="1"/>
          <p:nvPr/>
        </p:nvSpPr>
        <p:spPr>
          <a:xfrm>
            <a:off x="3641838" y="2964193"/>
            <a:ext cx="1098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S:BrrWUSa-GFP</a:t>
            </a:r>
            <a:endParaRPr lang="zh-CN" altLang="en-US" sz="8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6">
            <a:extLst>
              <a:ext uri="{FF2B5EF4-FFF2-40B4-BE49-F238E27FC236}">
                <a16:creationId xmlns="" xmlns:a16="http://schemas.microsoft.com/office/drawing/2014/main" id="{1F570B47-9755-4896-9DB9-F0F0B11B7181}"/>
              </a:ext>
            </a:extLst>
          </p:cNvPr>
          <p:cNvSpPr txBox="1"/>
          <p:nvPr/>
        </p:nvSpPr>
        <p:spPr>
          <a:xfrm>
            <a:off x="4806892" y="2964193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6">
            <a:extLst>
              <a:ext uri="{FF2B5EF4-FFF2-40B4-BE49-F238E27FC236}">
                <a16:creationId xmlns="" xmlns:a16="http://schemas.microsoft.com/office/drawing/2014/main" id="{E0B5F2D2-6EAF-4ED4-A8D6-99FAF3AC8104}"/>
              </a:ext>
            </a:extLst>
          </p:cNvPr>
          <p:cNvSpPr txBox="1"/>
          <p:nvPr/>
        </p:nvSpPr>
        <p:spPr>
          <a:xfrm>
            <a:off x="4989930" y="2964193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>
            <a:extLst>
              <a:ext uri="{FF2B5EF4-FFF2-40B4-BE49-F238E27FC236}">
                <a16:creationId xmlns="" xmlns:a16="http://schemas.microsoft.com/office/drawing/2014/main" id="{A64A1F27-DEBE-409D-8E89-F9B0B3B970C7}"/>
              </a:ext>
            </a:extLst>
          </p:cNvPr>
          <p:cNvCxnSpPr/>
          <p:nvPr/>
        </p:nvCxnSpPr>
        <p:spPr>
          <a:xfrm>
            <a:off x="5107926" y="3183812"/>
            <a:ext cx="163686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="" xmlns:a16="http://schemas.microsoft.com/office/drawing/2014/main" id="{A64A1F27-DEBE-409D-8E89-F9B0B3B970C7}"/>
              </a:ext>
            </a:extLst>
          </p:cNvPr>
          <p:cNvCxnSpPr/>
          <p:nvPr/>
        </p:nvCxnSpPr>
        <p:spPr>
          <a:xfrm>
            <a:off x="4919930" y="3191195"/>
            <a:ext cx="163686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="" xmlns:a16="http://schemas.microsoft.com/office/drawing/2014/main" id="{A64A1F27-DEBE-409D-8E89-F9B0B3B970C7}"/>
              </a:ext>
            </a:extLst>
          </p:cNvPr>
          <p:cNvCxnSpPr/>
          <p:nvPr/>
        </p:nvCxnSpPr>
        <p:spPr>
          <a:xfrm>
            <a:off x="3240945" y="3186151"/>
            <a:ext cx="163686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6">
            <a:extLst>
              <a:ext uri="{FF2B5EF4-FFF2-40B4-BE49-F238E27FC236}">
                <a16:creationId xmlns="" xmlns:a16="http://schemas.microsoft.com/office/drawing/2014/main" id="{75271B3B-B295-4121-8671-76AA96993B74}"/>
              </a:ext>
            </a:extLst>
          </p:cNvPr>
          <p:cNvSpPr txBox="1"/>
          <p:nvPr/>
        </p:nvSpPr>
        <p:spPr>
          <a:xfrm>
            <a:off x="3128942" y="2960374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1340069" y="6074824"/>
            <a:ext cx="1008993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w result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1h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ransgenic-specific PCR product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amplification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with primers GFP-F and </a:t>
            </a:r>
            <a:r>
              <a:rPr lang="en-US" altLang="zh-CN" sz="1200" kern="100" dirty="0" err="1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BrrWUSa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-R. M, DNA ladder marker DL2502. </a:t>
            </a:r>
            <a:endParaRPr lang="zh-CN" altLang="en-US" sz="1200" kern="100" dirty="0"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8341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5432" y="369611"/>
            <a:ext cx="7227693" cy="5400000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="" xmlns:a16="http://schemas.microsoft.com/office/drawing/2014/main" id="{498CEC85-3090-4D0A-962F-52AA11EBD161}"/>
              </a:ext>
            </a:extLst>
          </p:cNvPr>
          <p:cNvCxnSpPr/>
          <p:nvPr/>
        </p:nvCxnSpPr>
        <p:spPr>
          <a:xfrm>
            <a:off x="2936879" y="1369558"/>
            <a:ext cx="3119972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="" xmlns:a16="http://schemas.microsoft.com/office/drawing/2014/main" id="{17C655C8-0187-4187-A043-3458E63C2190}"/>
              </a:ext>
            </a:extLst>
          </p:cNvPr>
          <p:cNvCxnSpPr/>
          <p:nvPr/>
        </p:nvCxnSpPr>
        <p:spPr>
          <a:xfrm>
            <a:off x="6094656" y="1362207"/>
            <a:ext cx="16067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15">
            <a:extLst>
              <a:ext uri="{FF2B5EF4-FFF2-40B4-BE49-F238E27FC236}">
                <a16:creationId xmlns="" xmlns:a16="http://schemas.microsoft.com/office/drawing/2014/main" id="{02861760-5EA7-47CB-AAC9-328E8995A19B}"/>
              </a:ext>
            </a:extLst>
          </p:cNvPr>
          <p:cNvSpPr txBox="1"/>
          <p:nvPr/>
        </p:nvSpPr>
        <p:spPr>
          <a:xfrm>
            <a:off x="4038850" y="1142237"/>
            <a:ext cx="8194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ted plants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6">
            <a:extLst>
              <a:ext uri="{FF2B5EF4-FFF2-40B4-BE49-F238E27FC236}">
                <a16:creationId xmlns="" xmlns:a16="http://schemas.microsoft.com/office/drawing/2014/main" id="{1F570B47-9755-4896-9DB9-F0F0B11B7181}"/>
              </a:ext>
            </a:extLst>
          </p:cNvPr>
          <p:cNvSpPr txBox="1"/>
          <p:nvPr/>
        </p:nvSpPr>
        <p:spPr>
          <a:xfrm>
            <a:off x="5976890" y="1142237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="" xmlns:a16="http://schemas.microsoft.com/office/drawing/2014/main" id="{A6E21A8D-998E-401A-AD4B-63F53370166E}"/>
              </a:ext>
            </a:extLst>
          </p:cNvPr>
          <p:cNvCxnSpPr/>
          <p:nvPr/>
        </p:nvCxnSpPr>
        <p:spPr>
          <a:xfrm>
            <a:off x="6287110" y="1365564"/>
            <a:ext cx="5744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26">
            <a:extLst>
              <a:ext uri="{FF2B5EF4-FFF2-40B4-BE49-F238E27FC236}">
                <a16:creationId xmlns="" xmlns:a16="http://schemas.microsoft.com/office/drawing/2014/main" id="{75271B3B-B295-4121-8671-76AA96993B74}"/>
              </a:ext>
            </a:extLst>
          </p:cNvPr>
          <p:cNvSpPr txBox="1"/>
          <p:nvPr/>
        </p:nvSpPr>
        <p:spPr>
          <a:xfrm>
            <a:off x="2639853" y="1165992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26">
            <a:extLst>
              <a:ext uri="{FF2B5EF4-FFF2-40B4-BE49-F238E27FC236}">
                <a16:creationId xmlns="" xmlns:a16="http://schemas.microsoft.com/office/drawing/2014/main" id="{E0B5F2D2-6EAF-4ED4-A8D6-99FAF3AC8104}"/>
              </a:ext>
            </a:extLst>
          </p:cNvPr>
          <p:cNvSpPr txBox="1"/>
          <p:nvPr/>
        </p:nvSpPr>
        <p:spPr>
          <a:xfrm>
            <a:off x="6465300" y="1142237"/>
            <a:ext cx="396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zh-CN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="" xmlns:a16="http://schemas.microsoft.com/office/drawing/2014/main" id="{17C655C8-0187-4187-A043-3458E63C2190}"/>
              </a:ext>
            </a:extLst>
          </p:cNvPr>
          <p:cNvCxnSpPr/>
          <p:nvPr/>
        </p:nvCxnSpPr>
        <p:spPr>
          <a:xfrm>
            <a:off x="2740109" y="1362979"/>
            <a:ext cx="16067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矩形 13"/>
          <p:cNvSpPr/>
          <p:nvPr/>
        </p:nvSpPr>
        <p:spPr>
          <a:xfrm>
            <a:off x="1228159" y="6080572"/>
            <a:ext cx="936626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5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w result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r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ure4b. The first line is the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aw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ult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t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ransgenic-specific PCR product amplification with primers Cas9-F and Cas9-R. </a:t>
            </a:r>
          </a:p>
          <a:p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K, mock control; edited plants; </a:t>
            </a:r>
            <a:r>
              <a:rPr lang="en-US" altLang="zh-CN" sz="1200" kern="100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p, </a:t>
            </a:r>
            <a:r>
              <a:rPr lang="en-US" altLang="zh-CN" sz="1200" kern="100" dirty="0" smtClean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CRISPR-Cas9-BrrTCP4b plasmid. M, DNA ladder marker DL2502. </a:t>
            </a:r>
            <a:endParaRPr lang="zh-CN" altLang="en-US" sz="1200" kern="100" dirty="0">
              <a:latin typeface="Times New Roman" panose="02020603050405020304" pitchFamily="18" charset="0"/>
              <a:ea typeface="楷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00225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633584" y="984399"/>
            <a:ext cx="8274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endParaRPr lang="zh-CN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626207" y="959113"/>
            <a:ext cx="1729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uences(5’-3’)</a:t>
            </a:r>
            <a:endParaRPr lang="zh-CN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2"/>
          <p:cNvSpPr txBox="1">
            <a:spLocks noChangeArrowheads="1"/>
          </p:cNvSpPr>
          <p:nvPr/>
        </p:nvSpPr>
        <p:spPr bwMode="auto">
          <a:xfrm>
            <a:off x="4633583" y="1261398"/>
            <a:ext cx="4891373" cy="436431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68580" tIns="34290" rIns="68580" bIns="34290" anchor="t" anchorCtr="0">
            <a:noAutofit/>
          </a:bodyPr>
          <a:lstStyle/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101-GFP-F         ATGGTGAGCAAGGGCGAGGAGCT        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101-GFP-R        GGCCGCAGCTCCGGACTTGTA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rWUSa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             ATGGAGCAACCGCAACATCA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rWUSa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             TTAATCCGGTGAGACGCCTG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9-F                     CCTTTCCCATTCCTCCCACT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9-R                     AGGAATGACTCCTCCAGCCT</a:t>
            </a:r>
          </a:p>
          <a:p>
            <a:pPr>
              <a:lnSpc>
                <a:spcPct val="150000"/>
              </a:lnSpc>
            </a:pPr>
            <a:r>
              <a:rPr lang="en-US" sz="1000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BrrWUS</a:t>
            </a:r>
            <a:r>
              <a:rPr 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F	   GATGGACACCAACGACCGAT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WUS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	   GTTGGGCGATGAAGACGTTG</a:t>
            </a:r>
            <a:endParaRPr lang="zh-CN" altLang="en-US" sz="1000" kern="1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000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BrrWUSa</a:t>
            </a:r>
            <a:r>
              <a:rPr 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F          CATAGGCCTGCTTCGGTCAA</a:t>
            </a:r>
            <a:endParaRPr lang="zh-CN" altLang="en-US" sz="1000" kern="1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000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BrrWUSa</a:t>
            </a:r>
            <a:r>
              <a:rPr 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R          TCACCGTGCATAGGGAAGAG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WUSb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	  TGCAGGTACAGGCACTGAAT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WUSb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	  CGATTGTCCGTGCTTCCAGA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GIS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               GTGGACACCAAAACGCTCAC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GIS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               GCTGAGAACCAGCCAAGGAT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LOX2-F            ATGAGAAGGCGGAACATGGG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LOX2-R           GCCACGCCAATCAAGTCATC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TUB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              AGGCGTGTGAGTGAGCAGTT</a:t>
            </a:r>
          </a:p>
          <a:p>
            <a:pPr>
              <a:lnSpc>
                <a:spcPct val="150000"/>
              </a:lnSpc>
            </a:pPr>
            <a:r>
              <a:rPr lang="en-US" altLang="zh-CN" sz="100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BrrTUB</a:t>
            </a:r>
            <a:r>
              <a:rPr lang="en-US" altLang="zh-CN" sz="100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             CATCTCGTCCATTCCTTCACCTGT</a:t>
            </a:r>
            <a:endParaRPr lang="zh-CN" altLang="en-US" sz="1000" kern="1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en-US" sz="1000" kern="1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sz="10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</a:t>
            </a:r>
            <a:endParaRPr lang="zh-CN" altLang="en-US" sz="1000" kern="1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4633585" y="952357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4633583" y="5515150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4633584" y="1248975"/>
            <a:ext cx="36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矩形 14"/>
          <p:cNvSpPr/>
          <p:nvPr/>
        </p:nvSpPr>
        <p:spPr>
          <a:xfrm>
            <a:off x="4552183" y="607818"/>
            <a:ext cx="68961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endParaRPr lang="zh-CN" alt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4903814" y="5905360"/>
            <a:ext cx="23856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altLang="zh-CN" sz="1200" kern="1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ble S1 Primers used in this study.</a:t>
            </a:r>
            <a:endParaRPr lang="zh-CN" altLang="zh-CN" sz="1200" kern="100" dirty="0">
              <a:solidFill>
                <a:prstClr val="black"/>
              </a:solidFill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5331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686</TotalTime>
  <Words>375</Words>
  <Application>Microsoft Office PowerPoint</Application>
  <PresentationFormat>宽屏</PresentationFormat>
  <Paragraphs>75</Paragraphs>
  <Slides>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7" baseType="lpstr">
      <vt:lpstr>Adobe 黑体 Std R</vt:lpstr>
      <vt:lpstr>等线</vt:lpstr>
      <vt:lpstr>等线 Light</vt:lpstr>
      <vt:lpstr>楷体</vt:lpstr>
      <vt:lpstr>宋体</vt:lpstr>
      <vt:lpstr>Arial</vt:lpstr>
      <vt:lpstr>Calibri</vt:lpstr>
      <vt:lpstr>Comic Sans MS</vt:lpstr>
      <vt:lpstr>Times New Roman</vt:lpstr>
      <vt:lpstr>Office 主题​​</vt:lpstr>
      <vt:lpstr>SPW 10.0 Graph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杨永平</dc:creator>
  <cp:lastModifiedBy>Lenovo</cp:lastModifiedBy>
  <cp:revision>618</cp:revision>
  <dcterms:created xsi:type="dcterms:W3CDTF">2019-07-12T05:10:46Z</dcterms:created>
  <dcterms:modified xsi:type="dcterms:W3CDTF">2022-07-11T13:15:07Z</dcterms:modified>
</cp:coreProperties>
</file>